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5EB24-F803-4A59-9204-B60DDE90A4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63AA1-7F52-4161-ACEF-588B11094A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EAFE9-00F7-479F-8AEC-010E0C9CA5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38793-1B8C-46E4-B123-FECD158067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AC5D2-5181-4D8E-9FA5-5F021CDE69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AE934-8482-4DA6-9286-0E1538E210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6FD6A-3419-44B7-BC06-D767E6FB4A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5AD9B-15D3-488A-91D1-05A203F77E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EDC74-B463-4EFB-ABD7-D509E41A1D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33B4D-985D-4B61-8045-8520699F8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D4FA0-6FBB-4597-A881-BACCD18494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D7B7F-BE6E-4D2F-8CEC-E830F400A5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815F2B-E690-4B5A-8F73-AEFCA4DCBE4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6"/>
          <p:cNvSpPr/>
          <p:nvPr/>
        </p:nvSpPr>
        <p:spPr>
          <a:xfrm>
            <a:off x="6715080" y="6143760"/>
            <a:ext cx="2857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igure 1, Supplement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feld 7"/>
          <p:cNvSpPr/>
          <p:nvPr/>
        </p:nvSpPr>
        <p:spPr>
          <a:xfrm>
            <a:off x="428760" y="14292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1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feld 8"/>
          <p:cNvSpPr/>
          <p:nvPr/>
        </p:nvSpPr>
        <p:spPr>
          <a:xfrm>
            <a:off x="3429000" y="342900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1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feld 9"/>
          <p:cNvSpPr/>
          <p:nvPr/>
        </p:nvSpPr>
        <p:spPr>
          <a:xfrm>
            <a:off x="357120" y="3416400"/>
            <a:ext cx="7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1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10"/>
          <p:cNvSpPr/>
          <p:nvPr/>
        </p:nvSpPr>
        <p:spPr>
          <a:xfrm>
            <a:off x="6084720" y="142920"/>
            <a:ext cx="7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1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11"/>
          <p:cNvSpPr/>
          <p:nvPr/>
        </p:nvSpPr>
        <p:spPr>
          <a:xfrm>
            <a:off x="3286080" y="142920"/>
            <a:ext cx="7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1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Grafik 12" descr="MPO.emf"/>
          <p:cNvPicPr/>
          <p:nvPr/>
        </p:nvPicPr>
        <p:blipFill>
          <a:blip r:embed="rId1"/>
          <a:stretch/>
        </p:blipFill>
        <p:spPr>
          <a:xfrm>
            <a:off x="142920" y="357120"/>
            <a:ext cx="3176640" cy="3240000"/>
          </a:xfrm>
          <a:prstGeom prst="rect">
            <a:avLst/>
          </a:prstGeom>
          <a:ln w="0">
            <a:noFill/>
          </a:ln>
        </p:spPr>
      </p:pic>
      <p:pic>
        <p:nvPicPr>
          <p:cNvPr id="48" name="Grafik 13" descr="IL1ß.emf"/>
          <p:cNvPicPr/>
          <p:nvPr/>
        </p:nvPicPr>
        <p:blipFill>
          <a:blip r:embed="rId2"/>
          <a:stretch/>
        </p:blipFill>
        <p:spPr>
          <a:xfrm>
            <a:off x="2903400" y="360360"/>
            <a:ext cx="3168720" cy="3240000"/>
          </a:xfrm>
          <a:prstGeom prst="rect">
            <a:avLst/>
          </a:prstGeom>
          <a:ln w="0">
            <a:noFill/>
          </a:ln>
        </p:spPr>
      </p:pic>
      <p:pic>
        <p:nvPicPr>
          <p:cNvPr id="49" name="Grafik 14" descr="IL8.emf"/>
          <p:cNvPicPr/>
          <p:nvPr/>
        </p:nvPicPr>
        <p:blipFill>
          <a:blip r:embed="rId3"/>
          <a:stretch/>
        </p:blipFill>
        <p:spPr>
          <a:xfrm>
            <a:off x="5681520" y="374760"/>
            <a:ext cx="3176640" cy="3240000"/>
          </a:xfrm>
          <a:prstGeom prst="rect">
            <a:avLst/>
          </a:prstGeom>
          <a:ln w="0">
            <a:noFill/>
          </a:ln>
        </p:spPr>
      </p:pic>
      <p:pic>
        <p:nvPicPr>
          <p:cNvPr id="50" name="Grafik 15" descr="TNFa.emf"/>
          <p:cNvPicPr/>
          <p:nvPr/>
        </p:nvPicPr>
        <p:blipFill>
          <a:blip r:embed="rId4"/>
          <a:stretch/>
        </p:blipFill>
        <p:spPr>
          <a:xfrm>
            <a:off x="38160" y="3546360"/>
            <a:ext cx="3247920" cy="3240360"/>
          </a:xfrm>
          <a:prstGeom prst="rect">
            <a:avLst/>
          </a:prstGeom>
          <a:ln w="0">
            <a:noFill/>
          </a:ln>
        </p:spPr>
      </p:pic>
      <p:pic>
        <p:nvPicPr>
          <p:cNvPr id="51" name="Grafik 16" descr="PMNE.emf"/>
          <p:cNvPicPr/>
          <p:nvPr/>
        </p:nvPicPr>
        <p:blipFill>
          <a:blip r:embed="rId5"/>
          <a:stretch/>
        </p:blipFill>
        <p:spPr>
          <a:xfrm>
            <a:off x="3214800" y="3500280"/>
            <a:ext cx="3240000" cy="324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"/>
          <p:cNvSpPr/>
          <p:nvPr/>
        </p:nvSpPr>
        <p:spPr>
          <a:xfrm>
            <a:off x="642960" y="485280"/>
            <a:ext cx="7358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Figure S1 A-E: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Differences in inflammatory markers in healthy controls and CF patients before and during i.v.-antibiotic therapy. For myeloperoxidase, significant differences between CF and healthy controls were observed and a slight decline under AB intervention was found (S1A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IL-1ß (S1B) and IL-8 (S1C) levels were significantly lower in controls. TNF (S1D) was found to be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significantly elevated in CF but there was no change under AB treatment.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In PMNE (S1E) no changes were observed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under AB treatmen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ctangle 2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feld 4"/>
          <p:cNvSpPr/>
          <p:nvPr/>
        </p:nvSpPr>
        <p:spPr>
          <a:xfrm>
            <a:off x="6715080" y="6143760"/>
            <a:ext cx="2857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igure 2, Supplement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1"/>
          <a:stretch/>
        </p:blipFill>
        <p:spPr>
          <a:xfrm>
            <a:off x="2548080" y="1919160"/>
            <a:ext cx="4047840" cy="3019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1"/>
          <p:cNvSpPr/>
          <p:nvPr/>
        </p:nvSpPr>
        <p:spPr>
          <a:xfrm>
            <a:off x="642960" y="573120"/>
            <a:ext cx="7358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2: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ower IL-1ß levels in AZM-treated patients (median 140.6 ng/mL, range 4.1-467.2 vs. 747.1 ng/mL, range 219.5-779.3 in untreated patients,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=0.0348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8T19:34:19Z</dcterms:created>
  <dc:creator>keiner</dc:creator>
  <dc:description/>
  <dc:language>en-US</dc:language>
  <cp:lastModifiedBy>JHentschel</cp:lastModifiedBy>
  <dcterms:modified xsi:type="dcterms:W3CDTF">2014-03-10T09:40:21Z</dcterms:modified>
  <cp:revision>21</cp:revision>
  <dc:subject/>
  <dc:title>Folie 1</dc:title>
</cp:coreProperties>
</file>